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.R Joshi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16-03-01T00:01:54.949" idx="1">
    <p:pos x="2016" y="2007"/>
    <p:text/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2100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7365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1793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5243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0969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6615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39685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7575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60697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6965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3284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879B30ED-8AD1-B142-B4C3-579C2C6316E4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457200"/>
              <a:t>8/3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1D7D3E58-EC27-A249-9814-9B1C4F5A3C1F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457200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0919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omments" Target="../comments/commen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75440" y="280639"/>
            <a:ext cx="8051820" cy="2783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sz="1400" b="1" dirty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pplied Microbiology and Biotechnology</a:t>
            </a:r>
            <a:r>
              <a:rPr lang="en-US" sz="14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press</a:t>
            </a:r>
            <a:endParaRPr lang="en-IN" sz="1200" b="1" i="1" dirty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IN" sz="1200" b="1" dirty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sz="1200" b="1" dirty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sz="1200" b="1" dirty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defTabSz="45720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esium and strontium tolerant </a:t>
            </a:r>
            <a:r>
              <a:rPr lang="en-US" sz="1200" b="1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sp. strain KMSZP6 isolated from a pristine uranium ore deposit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defTabSz="457200">
              <a:lnSpc>
                <a:spcPct val="115000"/>
              </a:lnSpc>
              <a:tabLst>
                <a:tab pos="457200" algn="l"/>
              </a:tabLst>
            </a:pP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Pynskhem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Bok Swer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Santa Ram Joshi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Celin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Acharya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3*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algn="just" defTabSz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100" dirty="0">
                <a:solidFill>
                  <a:srgbClr val="00000A"/>
                </a:solidFill>
                <a:ea typeface="Calibri"/>
                <a:cs typeface="Times New Roman"/>
              </a:rPr>
              <a:t> </a:t>
            </a:r>
          </a:p>
          <a:p>
            <a:pPr algn="just" defTabSz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Department of Biotechnology and Bioinformatics, North Eastern Hill University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Umshi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Mawlai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hillo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- 793022, India  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 defTabSz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Molecular Biology Division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 Atomic Research Centre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Trombay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, Mumbai 400085, India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 defTabSz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3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Homi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tional Institute,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Anushakti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gar, Mumbai, 400094, India</a:t>
            </a:r>
            <a:r>
              <a:rPr lang="en-US" sz="1200" b="1" dirty="0">
                <a:solidFill>
                  <a:srgbClr val="00000A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          </a:t>
            </a:r>
            <a:endParaRPr lang="en-US" sz="1100" dirty="0">
              <a:solidFill>
                <a:srgbClr val="00000A"/>
              </a:solidFill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308097" y="4191000"/>
            <a:ext cx="4438074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  <a:tabLst>
                <a:tab pos="3390900" algn="l"/>
              </a:tabLst>
            </a:pPr>
            <a:r>
              <a:rPr lang="en-US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/>
            </a:r>
            <a:br>
              <a:rPr lang="en-US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endParaRPr lang="en-US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3390900" algn="l"/>
              </a:tabLst>
            </a:pP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Corresponding author,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3390900" algn="l"/>
              </a:tabLst>
            </a:pP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iling address: Molecular Biology Division, 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3390900" algn="l"/>
              </a:tabLst>
            </a:pPr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habha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tomic Research Centre, </a:t>
            </a:r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ombay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Mumbai 400 085, India. 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3390900" algn="l"/>
              </a:tabLst>
            </a:pP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one: +(91)22  25592256, E-mail: celin@barc.gov.in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582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ap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06" y="3185958"/>
            <a:ext cx="3189894" cy="3672042"/>
          </a:xfrm>
          <a:prstGeom prst="rect">
            <a:avLst/>
          </a:prstGeom>
        </p:spPr>
      </p:pic>
      <p:pic>
        <p:nvPicPr>
          <p:cNvPr id="4" name="Picture 3" descr="MAP2.jpg"/>
          <p:cNvPicPr>
            <a:picLocks noChangeAspect="1"/>
          </p:cNvPicPr>
          <p:nvPr/>
        </p:nvPicPr>
        <p:blipFill>
          <a:blip r:embed="rId3"/>
          <a:srcRect b="15385"/>
          <a:stretch>
            <a:fillRect/>
          </a:stretch>
        </p:blipFill>
        <p:spPr>
          <a:xfrm>
            <a:off x="2226966" y="609600"/>
            <a:ext cx="6108666" cy="3657600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 flipH="1" flipV="1">
            <a:off x="1686560" y="1391920"/>
            <a:ext cx="751840" cy="325628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2469932" y="4175760"/>
            <a:ext cx="5373588" cy="54864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762000" y="47244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</a:rPr>
              <a:t>INDI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91014" y="60960"/>
            <a:ext cx="853962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457200"/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. S1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Location of sampling site at </a:t>
            </a:r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omiasiat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ylleng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Mining Site 1 (KMS1, highlighted with a yellow circle was chosen as sampling point for isolation of </a:t>
            </a:r>
            <a:r>
              <a:rPr lang="en-US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sp.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MSZP6</a:t>
            </a:r>
            <a:r>
              <a:rPr lang="en-US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train and </a:t>
            </a:r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hysiocochemical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profiling (map created using ERDAS 2010 and ArcGIS 9.3 software) </a:t>
            </a:r>
          </a:p>
          <a:p>
            <a:pPr algn="just" defTabSz="457200"/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8" name="Oval 7"/>
          <p:cNvSpPr/>
          <p:nvPr/>
        </p:nvSpPr>
        <p:spPr>
          <a:xfrm>
            <a:off x="4212419" y="2863012"/>
            <a:ext cx="448408" cy="192175"/>
          </a:xfrm>
          <a:prstGeom prst="ellipse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endParaRPr lang="en-US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427344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4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lin</dc:creator>
  <cp:lastModifiedBy>Celin</cp:lastModifiedBy>
  <cp:revision>2</cp:revision>
  <dcterms:created xsi:type="dcterms:W3CDTF">2016-08-24T09:30:07Z</dcterms:created>
  <dcterms:modified xsi:type="dcterms:W3CDTF">2016-08-31T05:45:55Z</dcterms:modified>
</cp:coreProperties>
</file>